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93" autoAdjust="0"/>
    <p:restoredTop sz="94660"/>
  </p:normalViewPr>
  <p:slideViewPr>
    <p:cSldViewPr snapToGrid="0">
      <p:cViewPr>
        <p:scale>
          <a:sx n="66" d="100"/>
          <a:sy n="66" d="100"/>
        </p:scale>
        <p:origin x="-858" y="-27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08A44A6-D0B8-468B-BFBE-A6F69353A3F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Subtítulo 2">
            <a:extLst>
              <a:ext uri="{FF2B5EF4-FFF2-40B4-BE49-F238E27FC236}">
                <a16:creationId xmlns="" xmlns:a16="http://schemas.microsoft.com/office/drawing/2014/main" id="{290E30C0-4426-44F2-B38D-83D7577048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917EEF46-D7EB-4D3A-AA53-615246E712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527FA636-60C8-48E8-9696-2864BB1DFE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0C749B35-351D-44E4-A6A4-81EDCA1E8D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678138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547187D4-C034-4268-A707-B0B247BD28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A4623153-EC0B-470B-B21F-FE2A53E1D0B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CFF63E07-8F18-406C-90E1-C1A92C3933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F74D4F1B-C57A-43B9-B35B-3174569FAF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81BB55B2-B5AC-43A0-A892-3D897D91977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996800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="" xmlns:a16="http://schemas.microsoft.com/office/drawing/2014/main" id="{0E28F1BC-E526-4D1F-A611-9DB41941B50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vertical 2">
            <a:extLst>
              <a:ext uri="{FF2B5EF4-FFF2-40B4-BE49-F238E27FC236}">
                <a16:creationId xmlns="" xmlns:a16="http://schemas.microsoft.com/office/drawing/2014/main" id="{200B98A0-7387-4505-9EEB-BB9AF94866E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6FC0AB7C-4E39-4C43-B52C-86823D94A5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5566F087-04E0-4942-8115-E4B67FBEA7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FD82129D-EA5F-4A8D-974C-9C06FC716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5187464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84501D56-F7C5-4407-8FC9-5975A01B58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EA0B771E-1731-4F76-B225-D7BA4CE3AE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144FC62F-E345-405D-A2C2-243E0D6DAC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89FC7273-2FD6-401E-B343-D05AF31428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00FCF9CD-4D41-40DB-A75C-93A6A7BE7D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785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A5D566AA-19FB-4EDA-ACF2-F747B1EF98C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6A10D460-8764-446B-969F-033E6CCE0F0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4CEF4420-F4F9-4E06-B1BD-E3B5BA281B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AC59A41F-927C-45F6-B849-518999A27DA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14B0C8A3-D83A-40CB-AE79-5A59B175F0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299923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117B8BF5-0176-4913-B21A-27C31A7475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4E2B49FD-141B-4D90-B1AF-4452E44735F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D91BE131-E100-4208-B3BA-52B3F22C991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84E40116-3446-4E8D-9869-E53CD626C8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BA00AF64-9010-4ED4-AFB7-D429F18AA65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283EC42F-9C92-47E9-982B-C2CFF707FD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642027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37CF1373-DF14-45B4-9018-8736AB74B5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8D579247-B1D6-47A7-9D19-985C637E6EE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="" xmlns:a16="http://schemas.microsoft.com/office/drawing/2014/main" id="{DDFD7AE6-EB1F-45C6-8838-65AC795AB3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5" name="Marcador de texto 4">
            <a:extLst>
              <a:ext uri="{FF2B5EF4-FFF2-40B4-BE49-F238E27FC236}">
                <a16:creationId xmlns="" xmlns:a16="http://schemas.microsoft.com/office/drawing/2014/main" id="{7BE6424F-9AE7-40C9-A59F-7619EDEDCA4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="" xmlns:a16="http://schemas.microsoft.com/office/drawing/2014/main" id="{96108778-FF81-42BF-89FE-5C563991466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7" name="Marcador de fecha 6">
            <a:extLst>
              <a:ext uri="{FF2B5EF4-FFF2-40B4-BE49-F238E27FC236}">
                <a16:creationId xmlns="" xmlns:a16="http://schemas.microsoft.com/office/drawing/2014/main" id="{26DF539E-C698-4D2F-81F9-D1BB6FE0EF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8" name="Marcador de pie de página 7">
            <a:extLst>
              <a:ext uri="{FF2B5EF4-FFF2-40B4-BE49-F238E27FC236}">
                <a16:creationId xmlns="" xmlns:a16="http://schemas.microsoft.com/office/drawing/2014/main" id="{79D5D48C-B08A-499E-B7C6-E13416A605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="" xmlns:a16="http://schemas.microsoft.com/office/drawing/2014/main" id="{E0B9C1EC-53FD-4E17-96EA-9E46EC160F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74578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FF706E54-0C4F-4C37-A7A1-2FEDF38C3BA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fecha 2">
            <a:extLst>
              <a:ext uri="{FF2B5EF4-FFF2-40B4-BE49-F238E27FC236}">
                <a16:creationId xmlns="" xmlns:a16="http://schemas.microsoft.com/office/drawing/2014/main" id="{ACAE975A-AA0A-43F7-8DD3-4BC5070497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4" name="Marcador de pie de página 3">
            <a:extLst>
              <a:ext uri="{FF2B5EF4-FFF2-40B4-BE49-F238E27FC236}">
                <a16:creationId xmlns="" xmlns:a16="http://schemas.microsoft.com/office/drawing/2014/main" id="{87D7E06A-DD03-45C4-B47B-DF0C56BBBD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="" xmlns:a16="http://schemas.microsoft.com/office/drawing/2014/main" id="{C87DC052-D687-49CE-865E-ACE25CB66A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1197143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="" xmlns:a16="http://schemas.microsoft.com/office/drawing/2014/main" id="{B5DBCAAF-1FA8-4F9B-8B28-3233B77E8A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3" name="Marcador de pie de página 2">
            <a:extLst>
              <a:ext uri="{FF2B5EF4-FFF2-40B4-BE49-F238E27FC236}">
                <a16:creationId xmlns="" xmlns:a16="http://schemas.microsoft.com/office/drawing/2014/main" id="{CE6D0B3F-6FD4-4BCC-B726-2ECC4171B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="" xmlns:a16="http://schemas.microsoft.com/office/drawing/2014/main" id="{C0941047-D375-4F8C-BF8C-B7CF7F4A8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6766089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77368569-11CF-45F2-B0D7-0E29A86E199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contenido 2">
            <a:extLst>
              <a:ext uri="{FF2B5EF4-FFF2-40B4-BE49-F238E27FC236}">
                <a16:creationId xmlns="" xmlns:a16="http://schemas.microsoft.com/office/drawing/2014/main" id="{20C43750-D2B9-4C51-BDD9-5631213FF42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B92072AC-78F4-4352-BC2C-A11BDC0D254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3EB2A2DE-131B-435A-9DE2-8A35533179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C08D6DBF-C49B-4826-89AB-D909E906D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D0B03701-DDC1-4241-B711-010FE74F764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9495633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="" xmlns:a16="http://schemas.microsoft.com/office/drawing/2014/main" id="{1E993843-E365-4EB9-AF79-7E76C050EF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="" xmlns:a16="http://schemas.microsoft.com/office/drawing/2014/main" id="{57E69F64-EBDA-4156-835B-4A8E6F200EA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>
            <a:extLst>
              <a:ext uri="{FF2B5EF4-FFF2-40B4-BE49-F238E27FC236}">
                <a16:creationId xmlns="" xmlns:a16="http://schemas.microsoft.com/office/drawing/2014/main" id="{9BF93EB0-19B0-4067-BB32-2E5CC68A3A3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="" xmlns:a16="http://schemas.microsoft.com/office/drawing/2014/main" id="{86379981-B12D-4727-85A2-A4C767EE5F7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6" name="Marcador de pie de página 5">
            <a:extLst>
              <a:ext uri="{FF2B5EF4-FFF2-40B4-BE49-F238E27FC236}">
                <a16:creationId xmlns="" xmlns:a16="http://schemas.microsoft.com/office/drawing/2014/main" id="{7874F486-1666-49BA-9092-8C98A52F1C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="" xmlns:a16="http://schemas.microsoft.com/office/drawing/2014/main" id="{9563C595-BCB0-4CE3-AB94-A605EE283CA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714077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="" xmlns:a16="http://schemas.microsoft.com/office/drawing/2014/main" id="{486395F3-D2A8-42BD-B94B-5D0E2439F7F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</a:p>
        </p:txBody>
      </p:sp>
      <p:sp>
        <p:nvSpPr>
          <p:cNvPr id="3" name="Marcador de texto 2">
            <a:extLst>
              <a:ext uri="{FF2B5EF4-FFF2-40B4-BE49-F238E27FC236}">
                <a16:creationId xmlns="" xmlns:a16="http://schemas.microsoft.com/office/drawing/2014/main" id="{2280C8AA-5006-48D9-9E3B-6B315E06680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="" xmlns:a16="http://schemas.microsoft.com/office/drawing/2014/main" id="{7A30CEB4-8EDE-45A6-B567-D319AB4779F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345F8-D025-4B8A-A41F-C3010195A2EF}" type="datetimeFigureOut">
              <a:rPr lang="es-ES" smtClean="0"/>
              <a:t>22/10/2022</a:t>
            </a:fld>
            <a:endParaRPr lang="es-ES"/>
          </a:p>
        </p:txBody>
      </p:sp>
      <p:sp>
        <p:nvSpPr>
          <p:cNvPr id="5" name="Marcador de pie de página 4">
            <a:extLst>
              <a:ext uri="{FF2B5EF4-FFF2-40B4-BE49-F238E27FC236}">
                <a16:creationId xmlns="" xmlns:a16="http://schemas.microsoft.com/office/drawing/2014/main" id="{834AB917-874E-4518-AF2A-2EBF5B7CDA7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="" xmlns:a16="http://schemas.microsoft.com/office/drawing/2014/main" id="{79940789-0A0B-4695-AA8B-A24B62EC7A6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986EC1C-FC0A-4643-BD22-A76D61254A4E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14807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12 CuadroTexto">
            <a:extLst>
              <a:ext uri="{FF2B5EF4-FFF2-40B4-BE49-F238E27FC236}">
                <a16:creationId xmlns="" xmlns:a16="http://schemas.microsoft.com/office/drawing/2014/main" id="{ECD1EB9D-A0AA-4739-92CE-34858854137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71600" y="5322616"/>
            <a:ext cx="9448800" cy="73866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32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2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20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algn="just">
              <a:spcBef>
                <a:spcPct val="0"/>
              </a:spcBef>
              <a:buFontTx/>
              <a:buNone/>
            </a:pPr>
            <a:r>
              <a:rPr lang="en-US" sz="14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. </a:t>
            </a:r>
            <a:r>
              <a:rPr lang="en-US" sz="1400" b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2</a:t>
            </a:r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	DAVID analysis of the cellular localization of dysregulated proteins identified by LC-MS/MS.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Secretome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ysregulated proteins were mainly found in the extracellular space and exosome (p value &lt;0.05), whereas cell extract proteins were mainly observed in the cytoplasm, nucleus, membrane, endoplasmic reticulum and exosomes (p value &lt;0.02). </a:t>
            </a:r>
            <a:endParaRPr lang="en-US" altLang="es-ES" sz="14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" name="2 Grupo"/>
          <p:cNvGrpSpPr/>
          <p:nvPr/>
        </p:nvGrpSpPr>
        <p:grpSpPr>
          <a:xfrm>
            <a:off x="3254478" y="525763"/>
            <a:ext cx="5683045" cy="4298764"/>
            <a:chOff x="3244953" y="525763"/>
            <a:chExt cx="5683045" cy="4298764"/>
          </a:xfrm>
        </p:grpSpPr>
        <p:pic>
          <p:nvPicPr>
            <p:cNvPr id="21" name="Imagen 20" descr="Imagen que contiene Aplicación&#10;&#10;Descripción generada automáticamente">
              <a:extLst>
                <a:ext uri="{FF2B5EF4-FFF2-40B4-BE49-F238E27FC236}">
                  <a16:creationId xmlns="" xmlns:a16="http://schemas.microsoft.com/office/drawing/2014/main" id="{3092A999-D88B-4DB7-ADCE-A0C0F22610A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2703" r="74274" b="62037"/>
            <a:stretch/>
          </p:blipFill>
          <p:spPr>
            <a:xfrm>
              <a:off x="3244953" y="2053201"/>
              <a:ext cx="4660797" cy="2689976"/>
            </a:xfrm>
            <a:prstGeom prst="rect">
              <a:avLst/>
            </a:prstGeom>
          </p:spPr>
        </p:pic>
        <p:sp>
          <p:nvSpPr>
            <p:cNvPr id="4" name="CuadroTexto 3">
              <a:extLst>
                <a:ext uri="{FF2B5EF4-FFF2-40B4-BE49-F238E27FC236}">
                  <a16:creationId xmlns="" xmlns:a16="http://schemas.microsoft.com/office/drawing/2014/main" id="{27A66410-7338-4DF4-8DD3-46D40914B2FC}"/>
                </a:ext>
              </a:extLst>
            </p:cNvPr>
            <p:cNvSpPr txBox="1"/>
            <p:nvPr/>
          </p:nvSpPr>
          <p:spPr>
            <a:xfrm rot="16200000">
              <a:off x="2920555" y="1123558"/>
              <a:ext cx="15341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Cell extract</a:t>
              </a:r>
            </a:p>
          </p:txBody>
        </p:sp>
        <p:sp>
          <p:nvSpPr>
            <p:cNvPr id="10" name="CuadroTexto 9">
              <a:extLst>
                <a:ext uri="{FF2B5EF4-FFF2-40B4-BE49-F238E27FC236}">
                  <a16:creationId xmlns="" xmlns:a16="http://schemas.microsoft.com/office/drawing/2014/main" id="{BC963B72-4FE0-424F-87D4-4DB32E5114BE}"/>
                </a:ext>
              </a:extLst>
            </p:cNvPr>
            <p:cNvSpPr txBox="1"/>
            <p:nvPr/>
          </p:nvSpPr>
          <p:spPr>
            <a:xfrm rot="16200000">
              <a:off x="3644457" y="1123558"/>
              <a:ext cx="153414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b="1" dirty="0">
                  <a:latin typeface="Arial" panose="020B0604020202020204" pitchFamily="34" charset="0"/>
                  <a:cs typeface="Arial" panose="020B0604020202020204" pitchFamily="34" charset="0"/>
                </a:rPr>
                <a:t>Secretome</a:t>
              </a:r>
            </a:p>
          </p:txBody>
        </p:sp>
        <p:grpSp>
          <p:nvGrpSpPr>
            <p:cNvPr id="5" name="Grupo 4">
              <a:extLst>
                <a:ext uri="{FF2B5EF4-FFF2-40B4-BE49-F238E27FC236}">
                  <a16:creationId xmlns="" xmlns:a16="http://schemas.microsoft.com/office/drawing/2014/main" id="{3217E9C7-F9A8-4F8D-B3A5-C3DCB3D7C6AD}"/>
                </a:ext>
              </a:extLst>
            </p:cNvPr>
            <p:cNvGrpSpPr/>
            <p:nvPr/>
          </p:nvGrpSpPr>
          <p:grpSpPr>
            <a:xfrm>
              <a:off x="7153418" y="4140163"/>
              <a:ext cx="1774580" cy="684364"/>
              <a:chOff x="7170454" y="4062072"/>
              <a:chExt cx="1774580" cy="684364"/>
            </a:xfrm>
          </p:grpSpPr>
          <p:pic>
            <p:nvPicPr>
              <p:cNvPr id="11" name="Imagen 10" descr="Un conjunto de letras negras en un fondo blanco&#10;&#10;Descripción generada automáticamente con confianza media">
                <a:extLst>
                  <a:ext uri="{FF2B5EF4-FFF2-40B4-BE49-F238E27FC236}">
                    <a16:creationId xmlns="" xmlns:a16="http://schemas.microsoft.com/office/drawing/2014/main" id="{B5F582A0-36D1-450F-AA1D-F158F005537F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-364" r="91242" b="97943"/>
              <a:stretch/>
            </p:blipFill>
            <p:spPr>
              <a:xfrm>
                <a:off x="7287309" y="4320022"/>
                <a:ext cx="1420363" cy="230811"/>
              </a:xfrm>
              <a:prstGeom prst="rect">
                <a:avLst/>
              </a:prstGeom>
            </p:spPr>
          </p:pic>
          <p:sp>
            <p:nvSpPr>
              <p:cNvPr id="12" name="CuadroTexto 11">
                <a:extLst>
                  <a:ext uri="{FF2B5EF4-FFF2-40B4-BE49-F238E27FC236}">
                    <a16:creationId xmlns="" xmlns:a16="http://schemas.microsoft.com/office/drawing/2014/main" id="{B0039F19-2967-4093-95A6-37955BBAD040}"/>
                  </a:ext>
                </a:extLst>
              </p:cNvPr>
              <p:cNvSpPr txBox="1"/>
              <p:nvPr/>
            </p:nvSpPr>
            <p:spPr>
              <a:xfrm>
                <a:off x="8448921" y="4469437"/>
                <a:ext cx="4453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30</a:t>
                </a:r>
              </a:p>
            </p:txBody>
          </p:sp>
          <p:sp>
            <p:nvSpPr>
              <p:cNvPr id="13" name="CuadroTexto 12">
                <a:extLst>
                  <a:ext uri="{FF2B5EF4-FFF2-40B4-BE49-F238E27FC236}">
                    <a16:creationId xmlns="" xmlns:a16="http://schemas.microsoft.com/office/drawing/2014/main" id="{97380CC2-5F74-4BFB-8501-79C4D9D6E801}"/>
                  </a:ext>
                </a:extLst>
              </p:cNvPr>
              <p:cNvSpPr txBox="1"/>
              <p:nvPr/>
            </p:nvSpPr>
            <p:spPr>
              <a:xfrm>
                <a:off x="7170454" y="4469437"/>
                <a:ext cx="4453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0</a:t>
                </a:r>
              </a:p>
            </p:txBody>
          </p:sp>
          <p:sp>
            <p:nvSpPr>
              <p:cNvPr id="15" name="CuadroTexto 14">
                <a:extLst>
                  <a:ext uri="{FF2B5EF4-FFF2-40B4-BE49-F238E27FC236}">
                    <a16:creationId xmlns="" xmlns:a16="http://schemas.microsoft.com/office/drawing/2014/main" id="{D0D6C380-39C5-4E44-B0A3-0F92466F7335}"/>
                  </a:ext>
                </a:extLst>
              </p:cNvPr>
              <p:cNvSpPr txBox="1"/>
              <p:nvPr/>
            </p:nvSpPr>
            <p:spPr>
              <a:xfrm>
                <a:off x="7807066" y="4469436"/>
                <a:ext cx="445395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15</a:t>
                </a:r>
              </a:p>
            </p:txBody>
          </p:sp>
          <p:sp>
            <p:nvSpPr>
              <p:cNvPr id="17" name="CuadroTexto 16">
                <a:extLst>
                  <a:ext uri="{FF2B5EF4-FFF2-40B4-BE49-F238E27FC236}">
                    <a16:creationId xmlns="" xmlns:a16="http://schemas.microsoft.com/office/drawing/2014/main" id="{DCCC2F0E-F7BB-4D18-8CC2-C4137EA04F74}"/>
                  </a:ext>
                </a:extLst>
              </p:cNvPr>
              <p:cNvSpPr txBox="1"/>
              <p:nvPr/>
            </p:nvSpPr>
            <p:spPr>
              <a:xfrm>
                <a:off x="7227100" y="4062072"/>
                <a:ext cx="1717934" cy="276999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Number of proteins</a:t>
                </a: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529083534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39</TotalTime>
  <Words>12</Words>
  <Application>Microsoft Office PowerPoint</Application>
  <PresentationFormat>Personalizado</PresentationFormat>
  <Paragraphs>7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Tema de Office</vt:lpstr>
      <vt:lpstr>Presentación d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ANA MONTERO CALLE</dc:creator>
  <cp:lastModifiedBy>Rodrigo BM</cp:lastModifiedBy>
  <cp:revision>11</cp:revision>
  <dcterms:created xsi:type="dcterms:W3CDTF">2022-01-24T20:56:41Z</dcterms:created>
  <dcterms:modified xsi:type="dcterms:W3CDTF">2022-10-22T09:21:47Z</dcterms:modified>
</cp:coreProperties>
</file>